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6" r:id="rId2"/>
    <p:sldId id="263" r:id="rId3"/>
    <p:sldId id="264" r:id="rId4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00000"/>
    <a:srgbClr val="619654"/>
    <a:srgbClr val="B00000"/>
    <a:srgbClr val="7CB070"/>
    <a:srgbClr val="EA0000"/>
    <a:srgbClr val="800000"/>
    <a:srgbClr val="517E46"/>
    <a:srgbClr val="8A0000"/>
    <a:srgbClr val="8AB77F"/>
    <a:srgbClr val="002E1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 autoAdjust="0"/>
    <p:restoredTop sz="94692" autoAdjust="0"/>
  </p:normalViewPr>
  <p:slideViewPr>
    <p:cSldViewPr snapToGrid="0" showGuides="1">
      <p:cViewPr>
        <p:scale>
          <a:sx n="80" d="100"/>
          <a:sy n="80" d="100"/>
        </p:scale>
        <p:origin x="-1764" y="504"/>
      </p:cViewPr>
      <p:guideLst>
        <p:guide orient="horz" pos="1139"/>
        <p:guide pos="358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CHM.COM\dfs-1\SERVICES\IRHT\Lahlil%20Rachid\courant\Analyses\Bilan%20truecount.xls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\\CHM.COM\dfs-1\SERVICES\IRHT\Lahlil%20Rachid\courant\Analyses\Exp_UM171_SR1_synthese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044214737474997"/>
          <c:y val="3.4042060531907198E-2"/>
          <c:w val="0.7320419322584677"/>
          <c:h val="0.8481495076273361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1"/>
            <c:invertIfNegative val="0"/>
            <c:bubble3D val="0"/>
            <c:spPr>
              <a:solidFill>
                <a:srgbClr val="C00000"/>
              </a:solidFill>
            </c:spPr>
          </c:dPt>
          <c:dPt>
            <c:idx val="2"/>
            <c:invertIfNegative val="0"/>
            <c:bubble3D val="0"/>
            <c:spPr>
              <a:solidFill>
                <a:schemeClr val="tx1"/>
              </a:solidFill>
            </c:spPr>
          </c:dPt>
          <c:errBars>
            <c:errBarType val="plus"/>
            <c:errValType val="cust"/>
            <c:noEndCap val="0"/>
            <c:plus>
              <c:numRef>
                <c:f>Feuil1!$C$129:$C$131</c:f>
                <c:numCache>
                  <c:formatCode>General</c:formatCode>
                  <c:ptCount val="3"/>
                  <c:pt idx="0">
                    <c:v>145028.73278538059</c:v>
                  </c:pt>
                  <c:pt idx="1">
                    <c:v>1152165.7266415893</c:v>
                  </c:pt>
                  <c:pt idx="2">
                    <c:v>208936.35207564264</c:v>
                  </c:pt>
                </c:numCache>
              </c:numRef>
            </c:plus>
            <c:minus>
              <c:numRef>
                <c:f>Feuil1!$C$129:$C$131</c:f>
                <c:numCache>
                  <c:formatCode>General</c:formatCode>
                  <c:ptCount val="3"/>
                  <c:pt idx="0">
                    <c:v>145028.73278538059</c:v>
                  </c:pt>
                  <c:pt idx="1">
                    <c:v>1152165.7266415893</c:v>
                  </c:pt>
                  <c:pt idx="2">
                    <c:v>208936.35207564264</c:v>
                  </c:pt>
                </c:numCache>
              </c:numRef>
            </c:minus>
          </c:errBars>
          <c:cat>
            <c:strRef>
              <c:f>Feuil1!$A$129:$A$131</c:f>
              <c:strCache>
                <c:ptCount val="3"/>
                <c:pt idx="0">
                  <c:v>Day 0</c:v>
                </c:pt>
                <c:pt idx="1">
                  <c:v> Lin-/CD34+ </c:v>
                </c:pt>
                <c:pt idx="2">
                  <c:v>VSELs</c:v>
                </c:pt>
              </c:strCache>
            </c:strRef>
          </c:cat>
          <c:val>
            <c:numRef>
              <c:f>Feuil1!$B$129:$B$131</c:f>
              <c:numCache>
                <c:formatCode>0.00</c:formatCode>
                <c:ptCount val="3"/>
                <c:pt idx="0">
                  <c:v>296666.66666666669</c:v>
                </c:pt>
                <c:pt idx="1">
                  <c:v>6961103.0944364266</c:v>
                </c:pt>
                <c:pt idx="2">
                  <c:v>1267019.40035273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8119808"/>
        <c:axId val="198121344"/>
      </c:barChart>
      <c:catAx>
        <c:axId val="1981198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/>
            </a:pPr>
            <a:endParaRPr lang="fr-FR"/>
          </a:p>
        </c:txPr>
        <c:crossAx val="198121344"/>
        <c:crosses val="autoZero"/>
        <c:auto val="1"/>
        <c:lblAlgn val="ctr"/>
        <c:lblOffset val="100"/>
        <c:noMultiLvlLbl val="0"/>
      </c:catAx>
      <c:valAx>
        <c:axId val="1981213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fr-FR" sz="1400"/>
                  <a:t>Number of cells 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fr-FR"/>
          </a:p>
        </c:txPr>
        <c:crossAx val="1981198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3459253589298986"/>
          <c:y val="2.5424979772265308E-2"/>
          <c:w val="0.41259717535308088"/>
          <c:h val="0.20547693233006606"/>
        </c:manualLayout>
      </c:layout>
      <c:overlay val="0"/>
      <c:txPr>
        <a:bodyPr/>
        <a:lstStyle/>
        <a:p>
          <a:pPr>
            <a:defRPr sz="1100" b="1"/>
          </a:pPr>
          <a:endParaRPr lang="fr-FR"/>
        </a:p>
      </c:txPr>
    </c:legend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373025810994598"/>
          <c:y val="2.1701322187273515E-2"/>
          <c:w val="0.8437106248050007"/>
          <c:h val="0.7621062992125984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VS88'!$C$12</c:f>
              <c:strCache>
                <c:ptCount val="1"/>
                <c:pt idx="0">
                  <c:v>Control</c:v>
                </c:pt>
              </c:strCache>
            </c:strRef>
          </c:tx>
          <c:invertIfNegative val="0"/>
          <c:dLbls>
            <c:dLbl>
              <c:idx val="1"/>
              <c:layout>
                <c:manualLayout>
                  <c:x val="-1.6666666666666666E-2"/>
                  <c:y val="0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'VS88'!$B$13:$B$17</c:f>
              <c:strCache>
                <c:ptCount val="5"/>
                <c:pt idx="0">
                  <c:v>CD34</c:v>
                </c:pt>
                <c:pt idx="1">
                  <c:v>CD133</c:v>
                </c:pt>
                <c:pt idx="2">
                  <c:v>CD309</c:v>
                </c:pt>
                <c:pt idx="3">
                  <c:v>CD146</c:v>
                </c:pt>
                <c:pt idx="4">
                  <c:v>CD105</c:v>
                </c:pt>
              </c:strCache>
            </c:strRef>
          </c:cat>
          <c:val>
            <c:numRef>
              <c:f>'VS88'!$C$13:$C$17</c:f>
              <c:numCache>
                <c:formatCode>General</c:formatCode>
                <c:ptCount val="5"/>
                <c:pt idx="0">
                  <c:v>0.7</c:v>
                </c:pt>
                <c:pt idx="1">
                  <c:v>0.3</c:v>
                </c:pt>
                <c:pt idx="2">
                  <c:v>0.8</c:v>
                </c:pt>
                <c:pt idx="3">
                  <c:v>0.5</c:v>
                </c:pt>
                <c:pt idx="4">
                  <c:v>0.5</c:v>
                </c:pt>
              </c:numCache>
            </c:numRef>
          </c:val>
        </c:ser>
        <c:ser>
          <c:idx val="1"/>
          <c:order val="1"/>
          <c:tx>
            <c:strRef>
              <c:f>'VS88'!$D$12</c:f>
              <c:strCache>
                <c:ptCount val="1"/>
                <c:pt idx="0">
                  <c:v>VSELs</c:v>
                </c:pt>
              </c:strCache>
            </c:strRef>
          </c:tx>
          <c:invertIfNegative val="0"/>
          <c:dLbls>
            <c:txPr>
              <a:bodyPr/>
              <a:lstStyle/>
              <a:p>
                <a:pPr>
                  <a:defRPr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'VS88'!$B$13:$B$17</c:f>
              <c:strCache>
                <c:ptCount val="5"/>
                <c:pt idx="0">
                  <c:v>CD34</c:v>
                </c:pt>
                <c:pt idx="1">
                  <c:v>CD133</c:v>
                </c:pt>
                <c:pt idx="2">
                  <c:v>CD309</c:v>
                </c:pt>
                <c:pt idx="3">
                  <c:v>CD146</c:v>
                </c:pt>
                <c:pt idx="4">
                  <c:v>CD105</c:v>
                </c:pt>
              </c:strCache>
            </c:strRef>
          </c:cat>
          <c:val>
            <c:numRef>
              <c:f>'VS88'!$D$13:$D$17</c:f>
              <c:numCache>
                <c:formatCode>General</c:formatCode>
                <c:ptCount val="5"/>
                <c:pt idx="0">
                  <c:v>9.3000000000000007</c:v>
                </c:pt>
                <c:pt idx="1">
                  <c:v>2.1</c:v>
                </c:pt>
                <c:pt idx="2">
                  <c:v>10.4</c:v>
                </c:pt>
                <c:pt idx="3">
                  <c:v>3.7</c:v>
                </c:pt>
                <c:pt idx="4">
                  <c:v>3.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8177152"/>
        <c:axId val="198178688"/>
      </c:barChart>
      <c:catAx>
        <c:axId val="19817715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98178688"/>
        <c:crosses val="autoZero"/>
        <c:auto val="1"/>
        <c:lblAlgn val="ctr"/>
        <c:lblOffset val="100"/>
        <c:noMultiLvlLbl val="0"/>
      </c:catAx>
      <c:valAx>
        <c:axId val="1981786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fr-FR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s</a:t>
                </a:r>
                <a:r>
                  <a:rPr lang="fr-FR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%)</a:t>
                </a:r>
                <a:endParaRPr lang="fr-FR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81771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5441404199475059"/>
          <c:y val="2.9253426655001458E-2"/>
          <c:w val="0.20112073490813648"/>
          <c:h val="0.15177639253426656"/>
        </c:manualLayout>
      </c:layout>
      <c:overlay val="0"/>
      <c:txPr>
        <a:bodyPr/>
        <a:lstStyle/>
        <a:p>
          <a:pPr>
            <a:defRPr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fr-FR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02A019-9425-466A-8C46-890CA83893BD}" type="datetimeFigureOut">
              <a:rPr lang="fr-FR" smtClean="0"/>
              <a:t>29/03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C28D74-53AA-42B7-99AB-07B335E6B5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502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41994-FE88-4FA6-8E00-18C79A059EA9}" type="datetimeFigureOut">
              <a:rPr lang="fr-FR" smtClean="0"/>
              <a:t>29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7CCFC-077C-4A60-A268-01BB55CF40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49779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41994-FE88-4FA6-8E00-18C79A059EA9}" type="datetimeFigureOut">
              <a:rPr lang="fr-FR" smtClean="0"/>
              <a:t>29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7CCFC-077C-4A60-A268-01BB55CF40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784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41994-FE88-4FA6-8E00-18C79A059EA9}" type="datetimeFigureOut">
              <a:rPr lang="fr-FR" smtClean="0"/>
              <a:t>29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7CCFC-077C-4A60-A268-01BB55CF40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23097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41994-FE88-4FA6-8E00-18C79A059EA9}" type="datetimeFigureOut">
              <a:rPr lang="fr-FR" smtClean="0"/>
              <a:t>29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7CCFC-077C-4A60-A268-01BB55CF40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5447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41994-FE88-4FA6-8E00-18C79A059EA9}" type="datetimeFigureOut">
              <a:rPr lang="fr-FR" smtClean="0"/>
              <a:t>29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7CCFC-077C-4A60-A268-01BB55CF40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15394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41994-FE88-4FA6-8E00-18C79A059EA9}" type="datetimeFigureOut">
              <a:rPr lang="fr-FR" smtClean="0"/>
              <a:t>29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7CCFC-077C-4A60-A268-01BB55CF40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6782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41994-FE88-4FA6-8E00-18C79A059EA9}" type="datetimeFigureOut">
              <a:rPr lang="fr-FR" smtClean="0"/>
              <a:t>29/03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7CCFC-077C-4A60-A268-01BB55CF40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3038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41994-FE88-4FA6-8E00-18C79A059EA9}" type="datetimeFigureOut">
              <a:rPr lang="fr-FR" smtClean="0"/>
              <a:t>29/03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7CCFC-077C-4A60-A268-01BB55CF40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22978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41994-FE88-4FA6-8E00-18C79A059EA9}" type="datetimeFigureOut">
              <a:rPr lang="fr-FR" smtClean="0"/>
              <a:t>29/03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7CCFC-077C-4A60-A268-01BB55CF40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7535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41994-FE88-4FA6-8E00-18C79A059EA9}" type="datetimeFigureOut">
              <a:rPr lang="fr-FR" smtClean="0"/>
              <a:t>29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7CCFC-077C-4A60-A268-01BB55CF40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6816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41994-FE88-4FA6-8E00-18C79A059EA9}" type="datetimeFigureOut">
              <a:rPr lang="fr-FR" smtClean="0"/>
              <a:t>29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7CCFC-077C-4A60-A268-01BB55CF40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2293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941994-FE88-4FA6-8E00-18C79A059EA9}" type="datetimeFigureOut">
              <a:rPr lang="fr-FR" smtClean="0"/>
              <a:t>29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B7CCFC-077C-4A60-A268-01BB55CF40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1178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8865730"/>
              </p:ext>
            </p:extLst>
          </p:nvPr>
        </p:nvGraphicFramePr>
        <p:xfrm>
          <a:off x="1235033" y="1808163"/>
          <a:ext cx="3865727" cy="38004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476249" y="5606802"/>
            <a:ext cx="561579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/>
                <a:ea typeface="Calibri"/>
              </a:rPr>
              <a:t>Supplementary </a:t>
            </a:r>
            <a:r>
              <a:rPr lang="en-US" sz="1200" b="1" dirty="0" smtClean="0">
                <a:latin typeface="Times New Roman"/>
                <a:ea typeface="Calibri"/>
              </a:rPr>
              <a:t>Fig. 1</a:t>
            </a:r>
            <a:r>
              <a:rPr lang="en-US" sz="1200" b="1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. Absolute number of VSELs determination. 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solute number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ells/µL)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- CD34+ cells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El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rmin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using 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ucoun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™ followed by FACS analysis on day 0 and after 12 day of expansion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are presented as means ± SD for three individuals. 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94717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76249" y="3670300"/>
            <a:ext cx="576262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/>
                <a:ea typeface="Calibri"/>
              </a:rPr>
              <a:t>Supplementary Fig. 2. Endothelial differentiation. </a:t>
            </a:r>
            <a:r>
              <a:rPr lang="en-US" sz="1200" dirty="0" smtClean="0">
                <a:latin typeface="Times New Roman"/>
                <a:ea typeface="Calibri"/>
              </a:rPr>
              <a:t>After </a:t>
            </a:r>
            <a:r>
              <a:rPr lang="en-US" sz="1200" dirty="0">
                <a:latin typeface="Times New Roman"/>
                <a:ea typeface="Calibri"/>
              </a:rPr>
              <a:t>10 days of culture in the presence of expansion medium, </a:t>
            </a:r>
            <a:r>
              <a:rPr lang="en-US" sz="1200" dirty="0" smtClean="0">
                <a:latin typeface="Times New Roman"/>
                <a:ea typeface="Calibri"/>
              </a:rPr>
              <a:t>we </a:t>
            </a:r>
            <a:r>
              <a:rPr lang="en-US" sz="1200" dirty="0">
                <a:latin typeface="Times New Roman"/>
                <a:ea typeface="Calibri"/>
              </a:rPr>
              <a:t>isolated the VSELs, expressing the CD34+ CD133+ </a:t>
            </a:r>
            <a:r>
              <a:rPr lang="en-US" sz="1200" dirty="0" smtClean="0">
                <a:latin typeface="Times New Roman"/>
                <a:ea typeface="Calibri"/>
              </a:rPr>
              <a:t>markers </a:t>
            </a:r>
            <a:r>
              <a:rPr lang="en-US" sz="1200" dirty="0">
                <a:latin typeface="Times New Roman"/>
                <a:ea typeface="Calibri"/>
              </a:rPr>
              <a:t>and lacking the line markers Lin- and CD45-, </a:t>
            </a:r>
            <a:r>
              <a:rPr lang="en-US" sz="1200" dirty="0" smtClean="0">
                <a:latin typeface="Times New Roman"/>
                <a:ea typeface="Calibri"/>
              </a:rPr>
              <a:t>by </a:t>
            </a:r>
            <a:r>
              <a:rPr lang="en-US" sz="1200" dirty="0">
                <a:latin typeface="Times New Roman"/>
                <a:ea typeface="Calibri"/>
              </a:rPr>
              <a:t>sorting them by flow cytometry. After five days of culture, </a:t>
            </a:r>
            <a:r>
              <a:rPr lang="en-US" sz="1200" dirty="0" smtClean="0">
                <a:latin typeface="Times New Roman"/>
                <a:ea typeface="Calibri"/>
              </a:rPr>
              <a:t>the </a:t>
            </a:r>
            <a:r>
              <a:rPr lang="en-US" sz="1200" dirty="0">
                <a:latin typeface="Times New Roman"/>
                <a:ea typeface="Calibri"/>
              </a:rPr>
              <a:t>differentiated VSELs form </a:t>
            </a:r>
            <a:r>
              <a:rPr lang="en-US" sz="1200" dirty="0" err="1">
                <a:latin typeface="Times New Roman"/>
                <a:ea typeface="Calibri"/>
              </a:rPr>
              <a:t>embryoïd</a:t>
            </a:r>
            <a:r>
              <a:rPr lang="en-US" sz="1200" dirty="0">
                <a:latin typeface="Times New Roman"/>
                <a:ea typeface="Calibri"/>
              </a:rPr>
              <a:t> bodies like structures that were collected </a:t>
            </a:r>
            <a:r>
              <a:rPr lang="en-US" sz="1200" dirty="0" smtClean="0">
                <a:latin typeface="Times New Roman"/>
                <a:ea typeface="Calibri"/>
              </a:rPr>
              <a:t>and </a:t>
            </a:r>
            <a:r>
              <a:rPr lang="en-US" sz="1200" dirty="0">
                <a:latin typeface="Times New Roman"/>
                <a:ea typeface="Calibri"/>
              </a:rPr>
              <a:t>in which, the expression of endothelial markers CD309, CD146, and </a:t>
            </a:r>
            <a:r>
              <a:rPr lang="en-US" sz="1200" dirty="0" smtClean="0">
                <a:latin typeface="Times New Roman"/>
                <a:ea typeface="Calibri"/>
              </a:rPr>
              <a:t>CD105 </a:t>
            </a:r>
            <a:r>
              <a:rPr lang="en-US" sz="1200" dirty="0">
                <a:latin typeface="Times New Roman"/>
                <a:ea typeface="Calibri"/>
              </a:rPr>
              <a:t>were measured. As </a:t>
            </a:r>
            <a:r>
              <a:rPr lang="en-US" sz="1200" dirty="0" smtClean="0">
                <a:latin typeface="Times New Roman"/>
                <a:ea typeface="Calibri"/>
              </a:rPr>
              <a:t>shown, expression </a:t>
            </a:r>
            <a:r>
              <a:rPr lang="en-US" sz="1200" dirty="0">
                <a:latin typeface="Times New Roman"/>
                <a:ea typeface="Calibri"/>
              </a:rPr>
              <a:t>of these receptors is significantly </a:t>
            </a:r>
            <a:r>
              <a:rPr lang="en-US" sz="1200" dirty="0" smtClean="0">
                <a:latin typeface="Times New Roman"/>
                <a:ea typeface="Calibri"/>
              </a:rPr>
              <a:t>increased </a:t>
            </a:r>
            <a:r>
              <a:rPr lang="en-US" sz="1200" dirty="0">
                <a:latin typeface="Times New Roman"/>
                <a:ea typeface="Calibri"/>
              </a:rPr>
              <a:t>in the cultures containing VSELs relative to the control cells </a:t>
            </a:r>
            <a:r>
              <a:rPr lang="en-US" sz="1200" dirty="0" smtClean="0">
                <a:latin typeface="Times New Roman"/>
                <a:ea typeface="Calibri"/>
              </a:rPr>
              <a:t>CD133-. </a:t>
            </a:r>
            <a:endParaRPr lang="fr-FR" sz="1200" dirty="0"/>
          </a:p>
        </p:txBody>
      </p:sp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5739388"/>
              </p:ext>
            </p:extLst>
          </p:nvPr>
        </p:nvGraphicFramePr>
        <p:xfrm>
          <a:off x="1567490" y="839573"/>
          <a:ext cx="3580141" cy="23853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2485961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8647203"/>
              </p:ext>
            </p:extLst>
          </p:nvPr>
        </p:nvGraphicFramePr>
        <p:xfrm>
          <a:off x="473621" y="1377538"/>
          <a:ext cx="6140934" cy="381029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05013"/>
                <a:gridCol w="2454729"/>
                <a:gridCol w="2581192"/>
              </a:tblGrid>
              <a:tr h="329058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i="0" u="none" strike="noStrike" dirty="0" err="1" smtClean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ligo</a:t>
                      </a:r>
                      <a:r>
                        <a:rPr lang="fr-FR" sz="1200" b="1" i="0" u="none" strike="noStrike" baseline="0" dirty="0" smtClean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1200" b="1" i="0" u="none" strike="noStrike" baseline="0" dirty="0" err="1" smtClean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0103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2  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TCAGGATGCAGATGGG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TCACTGGGAGTGACCTT</a:t>
                      </a:r>
                      <a:endParaRPr lang="fr-FR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0103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4 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TGGGGCCGTAGGAACCG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ACTGGCTCATATCGAGAG</a:t>
                      </a:r>
                      <a:endParaRPr lang="fr-FR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0103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1 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CGGGATCTACCATACCC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TCTACCCTTATACACAACTCC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0103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T-4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GTGGTCCGAGTGTGGTTC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TGCATAGTCGCTGCTTGA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0103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PDX1</a:t>
                      </a:r>
                      <a:endParaRPr lang="fr-FR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GCTGCCTTTCCCATGGATGA </a:t>
                      </a:r>
                      <a:endParaRPr lang="fr-FR" sz="1200" dirty="0" smtClean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CTTGTTCTCCTCCGGCTCC </a:t>
                      </a:r>
                      <a:endParaRPr kumimoji="0" lang="fr-FR" sz="1200" b="0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0103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NOG 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GAAGGCCTCAGCACCT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TTCCCAGTCGGGTTC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010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T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GCCTCAAAAGAAGAAACC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TGTTCAATCGCTTCTTGCT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010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IL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ACCTCTGAGGATGCCTT 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ATTGCATTGACCCTGG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010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X2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GAGTGGAAACTTTTGTC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GCGTGTACTTATCCTTCT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010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X17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CCAGACCTGCACAACG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CGGTACTTGTAGTTGG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010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3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GGACTGAGCATCGAGCA 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GTGATCTGACACCCTGAA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0103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microglobulin 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ACTTTGTCACAGCCCAAGAT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GCGGCATCTTCAAACC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356257" y="5363582"/>
            <a:ext cx="625829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200" b="1" dirty="0" smtClean="0">
                <a:solidFill>
                  <a:prstClr val="black"/>
                </a:solidFill>
                <a:latin typeface="Times New Roman"/>
                <a:ea typeface="Calibri"/>
              </a:rPr>
              <a:t>Supplementary Table 1 :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Oligonucleotides used for real time RT-PCR genes amplification from human UCB.</a:t>
            </a:r>
            <a:endParaRPr lang="fr-FR" sz="12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7471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2069</TotalTime>
  <Words>224</Words>
  <Application>Microsoft Office PowerPoint</Application>
  <PresentationFormat>Affichage à l'écran (4:3)</PresentationFormat>
  <Paragraphs>45</Paragraphs>
  <Slides>3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4" baseType="lpstr">
      <vt:lpstr>Thème Office</vt:lpstr>
      <vt:lpstr>Présentation PowerPoint</vt:lpstr>
      <vt:lpstr>Présentation PowerPoint</vt:lpstr>
      <vt:lpstr>Présentation PowerPoint</vt:lpstr>
    </vt:vector>
  </TitlesOfParts>
  <Company>Centre Hospitalier de Mulhous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AHLIL Rachid</dc:creator>
  <cp:lastModifiedBy>LAHLIL Rachid</cp:lastModifiedBy>
  <cp:revision>205</cp:revision>
  <cp:lastPrinted>2018-03-29T08:15:26Z</cp:lastPrinted>
  <dcterms:created xsi:type="dcterms:W3CDTF">2017-01-23T14:29:31Z</dcterms:created>
  <dcterms:modified xsi:type="dcterms:W3CDTF">2018-03-29T09:05:29Z</dcterms:modified>
</cp:coreProperties>
</file>